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7561263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32" y="-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5" y="1749795"/>
            <a:ext cx="6427074" cy="3722335"/>
          </a:xfrm>
        </p:spPr>
        <p:txBody>
          <a:bodyPr anchor="b"/>
          <a:lstStyle>
            <a:lvl1pPr algn="ctr"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158" y="5615678"/>
            <a:ext cx="5670947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059" indent="0" algn="ctr">
              <a:buNone/>
              <a:defRPr sz="1654"/>
            </a:lvl2pPr>
            <a:lvl3pPr marL="756117" indent="0" algn="ctr">
              <a:buNone/>
              <a:defRPr sz="1488"/>
            </a:lvl3pPr>
            <a:lvl4pPr marL="1134176" indent="0" algn="ctr">
              <a:buNone/>
              <a:defRPr sz="1323"/>
            </a:lvl4pPr>
            <a:lvl5pPr marL="1512235" indent="0" algn="ctr">
              <a:buNone/>
              <a:defRPr sz="1323"/>
            </a:lvl5pPr>
            <a:lvl6pPr marL="1890293" indent="0" algn="ctr">
              <a:buNone/>
              <a:defRPr sz="1323"/>
            </a:lvl6pPr>
            <a:lvl7pPr marL="2268352" indent="0" algn="ctr">
              <a:buNone/>
              <a:defRPr sz="1323"/>
            </a:lvl7pPr>
            <a:lvl8pPr marL="2646411" indent="0" algn="ctr">
              <a:buNone/>
              <a:defRPr sz="1323"/>
            </a:lvl8pPr>
            <a:lvl9pPr marL="3024469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24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145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1029" y="569240"/>
            <a:ext cx="1630397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837" y="569240"/>
            <a:ext cx="4796676" cy="90608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37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6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899" y="2665532"/>
            <a:ext cx="6521589" cy="4447496"/>
          </a:xfrm>
        </p:spPr>
        <p:txBody>
          <a:bodyPr anchor="b"/>
          <a:lstStyle>
            <a:lvl1pPr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899" y="7155103"/>
            <a:ext cx="6521589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05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117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417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235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29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35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641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44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02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837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889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458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569242"/>
            <a:ext cx="6521589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823" y="2620980"/>
            <a:ext cx="3198768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823" y="3905482"/>
            <a:ext cx="3198768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890" y="2620980"/>
            <a:ext cx="3214522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890" y="3905482"/>
            <a:ext cx="3214522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949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157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791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522" y="1539425"/>
            <a:ext cx="3827889" cy="7598117"/>
          </a:xfrm>
        </p:spPr>
        <p:txBody>
          <a:bodyPr/>
          <a:lstStyle>
            <a:lvl1pPr>
              <a:defRPr sz="2646"/>
            </a:lvl1pPr>
            <a:lvl2pPr>
              <a:defRPr sz="2315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848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4522" y="1539425"/>
            <a:ext cx="3827889" cy="7598117"/>
          </a:xfrm>
        </p:spPr>
        <p:txBody>
          <a:bodyPr anchor="t"/>
          <a:lstStyle>
            <a:lvl1pPr marL="0" indent="0">
              <a:buNone/>
              <a:defRPr sz="2646"/>
            </a:lvl1pPr>
            <a:lvl2pPr marL="378059" indent="0">
              <a:buNone/>
              <a:defRPr sz="2315"/>
            </a:lvl2pPr>
            <a:lvl3pPr marL="756117" indent="0">
              <a:buNone/>
              <a:defRPr sz="1985"/>
            </a:lvl3pPr>
            <a:lvl4pPr marL="1134176" indent="0">
              <a:buNone/>
              <a:defRPr sz="1654"/>
            </a:lvl4pPr>
            <a:lvl5pPr marL="1512235" indent="0">
              <a:buNone/>
              <a:defRPr sz="1654"/>
            </a:lvl5pPr>
            <a:lvl6pPr marL="1890293" indent="0">
              <a:buNone/>
              <a:defRPr sz="1654"/>
            </a:lvl6pPr>
            <a:lvl7pPr marL="2268352" indent="0">
              <a:buNone/>
              <a:defRPr sz="1654"/>
            </a:lvl7pPr>
            <a:lvl8pPr marL="2646411" indent="0">
              <a:buNone/>
              <a:defRPr sz="1654"/>
            </a:lvl8pPr>
            <a:lvl9pPr marL="3024469" indent="0">
              <a:buNone/>
              <a:defRPr sz="165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879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837" y="569242"/>
            <a:ext cx="652158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837" y="2846200"/>
            <a:ext cx="652158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837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CF6DD-FF4F-451B-B8C2-4F18D3D8B354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669" y="9909729"/>
            <a:ext cx="2551926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0142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24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6117" rtl="0" eaLnBrk="1" latinLnBrk="0" hangingPunct="1">
        <a:lnSpc>
          <a:spcPct val="90000"/>
        </a:lnSpc>
        <a:spcBef>
          <a:spcPct val="0"/>
        </a:spcBef>
        <a:buNone/>
        <a:defRPr sz="36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29" indent="-189029" algn="l" defTabSz="756117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88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147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205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1264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9323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7381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5440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3499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805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6117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4176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2235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90293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8352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6411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446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3">
            <a:extLst>
              <a:ext uri="{FF2B5EF4-FFF2-40B4-BE49-F238E27FC236}">
                <a16:creationId xmlns:a16="http://schemas.microsoft.com/office/drawing/2014/main" id="{D96434AD-6FD5-4BB4-94BD-11C688BC5E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9259266"/>
              </p:ext>
            </p:extLst>
          </p:nvPr>
        </p:nvGraphicFramePr>
        <p:xfrm>
          <a:off x="296515" y="1206040"/>
          <a:ext cx="7056785" cy="4157736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693077">
                  <a:extLst>
                    <a:ext uri="{9D8B030D-6E8A-4147-A177-3AD203B41FA5}">
                      <a16:colId xmlns:a16="http://schemas.microsoft.com/office/drawing/2014/main" val="468892368"/>
                    </a:ext>
                  </a:extLst>
                </a:gridCol>
                <a:gridCol w="567063">
                  <a:extLst>
                    <a:ext uri="{9D8B030D-6E8A-4147-A177-3AD203B41FA5}">
                      <a16:colId xmlns:a16="http://schemas.microsoft.com/office/drawing/2014/main" val="1524784418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2614935393"/>
                    </a:ext>
                  </a:extLst>
                </a:gridCol>
                <a:gridCol w="819091">
                  <a:extLst>
                    <a:ext uri="{9D8B030D-6E8A-4147-A177-3AD203B41FA5}">
                      <a16:colId xmlns:a16="http://schemas.microsoft.com/office/drawing/2014/main" val="968524785"/>
                    </a:ext>
                  </a:extLst>
                </a:gridCol>
                <a:gridCol w="1524773">
                  <a:extLst>
                    <a:ext uri="{9D8B030D-6E8A-4147-A177-3AD203B41FA5}">
                      <a16:colId xmlns:a16="http://schemas.microsoft.com/office/drawing/2014/main" val="703269916"/>
                    </a:ext>
                  </a:extLst>
                </a:gridCol>
                <a:gridCol w="1292539">
                  <a:extLst>
                    <a:ext uri="{9D8B030D-6E8A-4147-A177-3AD203B41FA5}">
                      <a16:colId xmlns:a16="http://schemas.microsoft.com/office/drawing/2014/main" val="2586735530"/>
                    </a:ext>
                  </a:extLst>
                </a:gridCol>
                <a:gridCol w="1656186">
                  <a:extLst>
                    <a:ext uri="{9D8B030D-6E8A-4147-A177-3AD203B41FA5}">
                      <a16:colId xmlns:a16="http://schemas.microsoft.com/office/drawing/2014/main" val="1776713883"/>
                    </a:ext>
                  </a:extLst>
                </a:gridCol>
              </a:tblGrid>
              <a:tr h="3557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ample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+mn-lt"/>
                          <a:cs typeface="Arial" panose="020B0604020202020204" pitchFamily="34" charset="0"/>
                        </a:rPr>
                        <a:t>Age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ex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Grade OA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Arial" panose="020B0604020202020204" pitchFamily="34" charset="0"/>
                        </a:rPr>
                        <a:t>Used</a:t>
                      </a: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Arial" panose="020B0604020202020204" pitchFamily="34" charset="0"/>
                        </a:rPr>
                        <a:t> for transcriptome </a:t>
                      </a:r>
                      <a:r>
                        <a:rPr lang="fr-BE" sz="1100" i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Arial" panose="020B0604020202020204" pitchFamily="34" charset="0"/>
                        </a:rPr>
                        <a:t>analysis</a:t>
                      </a:r>
                      <a:endParaRPr lang="fr-BE" sz="1100" i="0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0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ed for alginate bead cultures</a:t>
                      </a:r>
                      <a:endParaRPr lang="fr-BE" sz="1100" i="0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ed</a:t>
                      </a:r>
                      <a:r>
                        <a:rPr lang="fr-BE" sz="1100" b="1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for </a:t>
                      </a:r>
                      <a:r>
                        <a:rPr lang="fr-BE" sz="1100" b="1" i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nolayer</a:t>
                      </a: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ultures</a:t>
                      </a:r>
                      <a:endParaRPr lang="fr-BE" sz="1100" i="0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98111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CR02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+mn-lt"/>
                        </a:rPr>
                        <a:t>71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IV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CR02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901193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CR03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+mn-lt"/>
                        </a:rPr>
                        <a:t>59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V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CR03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80561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4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74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II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4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934373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6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79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V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6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2400532"/>
                  </a:ext>
                </a:extLst>
              </a:tr>
              <a:tr h="67704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7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73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V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7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124094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8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67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M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V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8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5010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9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69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M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II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09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32102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10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79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II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10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27474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11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77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II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11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38624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12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>
                          <a:effectLst/>
                          <a:latin typeface="+mn-lt"/>
                        </a:rPr>
                        <a:t>62</a:t>
                      </a:r>
                      <a:endParaRPr lang="fr-BE" sz="1100" i="1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II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dirty="0">
                          <a:effectLst/>
                          <a:latin typeface="+mn-lt"/>
                        </a:rPr>
                        <a:t>CR12</a:t>
                      </a: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509703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4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II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L01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97634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5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7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V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L02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580642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8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V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3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L03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20084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9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8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W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V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4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29362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0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4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V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4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994780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1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V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5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L04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54442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2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1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W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II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5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L05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082546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3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W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II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6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094921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4</a:t>
                      </a:r>
                      <a:endParaRPr lang="fr-BE" sz="1100" b="1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</a:t>
                      </a:r>
                      <a:endParaRPr lang="fr-BE" sz="1100" b="0" i="1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W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/>
                          <a:cs typeface="Times New Roman" panose="02020603050405020304" pitchFamily="18" charset="0"/>
                        </a:rPr>
                        <a:t>IV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BE" sz="1100" i="1" dirty="0">
                        <a:solidFill>
                          <a:srgbClr val="365F9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6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BE" sz="1100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L06</a:t>
                      </a:r>
                      <a:endParaRPr lang="fr-BE" sz="1100" b="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56084753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FB0CE622-DCEC-4D2D-AA7A-9D7F634FCE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515" y="5565224"/>
            <a:ext cx="7056785" cy="1754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2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upplementary File </a:t>
            </a:r>
            <a:r>
              <a:rPr lang="en-US" altLang="fr-FR" sz="1200" dirty="0" bmk="_Toc526243385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1</a:t>
            </a:r>
            <a:r>
              <a:rPr kumimoji="0" lang="en-US" altLang="fr-FR" sz="1200" u="none" strike="noStrike" cap="none" normalizeH="0" baseline="0" dirty="0" bmk="_Toc526243385">
                <a:ln>
                  <a:noFill/>
                </a:ln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: Patients’ characteristics.</a:t>
            </a:r>
            <a:r>
              <a:rPr lang="en-US" altLang="fr-FR" sz="12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 </a:t>
            </a:r>
            <a:endParaRPr kumimoji="0" lang="fr-BE" altLang="fr-FR" sz="120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charset="-128"/>
                <a:cs typeface="Times New Roman" panose="02020603050405020304" pitchFamily="18" charset="0"/>
              </a:rPr>
              <a:t>For macroscopic assessment of the cartilage (grade OA) we used a score coming from the Collins diagram </a:t>
            </a:r>
            <a:r>
              <a:rPr kumimoji="0" lang="en-US" altLang="fr-FR" sz="1200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charset="-128"/>
                <a:cs typeface="Times New Roman" panose="02020603050405020304" pitchFamily="18" charset="0"/>
              </a:rPr>
              <a:t>(Collins and Mc 1960)</a:t>
            </a:r>
            <a:r>
              <a:rPr kumimoji="0" lang="en-US" altLang="fr-FR" sz="12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charset="-128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charset="-128"/>
                <a:cs typeface="Times New Roman" panose="02020603050405020304" pitchFamily="18" charset="0"/>
              </a:rPr>
              <a:t>Five different grades were considered: 0, normal white cartilage in all areas examined; I, the presence of a yellow-grey area with some superficial fibrillations on one or more articular surfaces; II, irregular surface with deep fibrillations on one or more articular surfaces; III, ulcers penetrating to the subchondral bone on one or more articular surfaces, with less than 50% of the articular surface showing subchondral bone denuded from cartilage; IV, in grade IV more than 50% of the articular surface is showing subchondral bone denuded from cartilage.</a:t>
            </a:r>
            <a:endParaRPr kumimoji="0" lang="en-US" altLang="fr-FR" sz="12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515" y="249411"/>
            <a:ext cx="1383912" cy="493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5604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D96A27105234489861BEF6E86B06D4" ma:contentTypeVersion="22" ma:contentTypeDescription="Create a new document." ma:contentTypeScope="" ma:versionID="dca18c0433d84dd0ea16714a5807ab0b">
  <xsd:schema xmlns:xsd="http://www.w3.org/2001/XMLSchema" xmlns:xs="http://www.w3.org/2001/XMLSchema" xmlns:p="http://schemas.microsoft.com/office/2006/metadata/properties" xmlns:ns2="http://schemas.microsoft.com/sharepoint/v3/fields" xmlns:ns3="059fc547-a1e4-4b8d-82b9-78eec4423d84" xmlns:ns4="4762b03c-6c27-4192-848d-cb0b6cbee78a" targetNamespace="http://schemas.microsoft.com/office/2006/metadata/properties" ma:root="true" ma:fieldsID="51cc04f524575326c24ee35f3d2aec87" ns2:_="" ns3:_="" ns4:_="">
    <xsd:import namespace="http://schemas.microsoft.com/sharepoint/v3/fields"/>
    <xsd:import namespace="059fc547-a1e4-4b8d-82b9-78eec4423d84"/>
    <xsd:import namespace="4762b03c-6c27-4192-848d-cb0b6cbee78a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3:Finished" minOccurs="0"/>
                <xsd:element ref="ns3:TaxKeywordTaxHTField" minOccurs="0"/>
                <xsd:element ref="ns3:TaxCatchAll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3:SharedWithUsers" minOccurs="0"/>
                <xsd:element ref="ns3:SharedWithDetails" minOccurs="0"/>
                <xsd:element ref="ns4:MediaServiceDateTaken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format="Dropdown" ma:internalName="_Status" ma:readOnly="false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59fc547-a1e4-4b8d-82b9-78eec4423d84" elementFormDefault="qualified">
    <xsd:import namespace="http://schemas.microsoft.com/office/2006/documentManagement/types"/>
    <xsd:import namespace="http://schemas.microsoft.com/office/infopath/2007/PartnerControls"/>
    <xsd:element name="Finished" ma:index="9" nillable="true" ma:displayName="Finished" ma:default="0" ma:internalName="Finished" ma:readOnly="false">
      <xsd:simpleType>
        <xsd:restriction base="dms:Boolean"/>
      </xsd:simpleType>
    </xsd:element>
    <xsd:element name="TaxKeywordTaxHTField" ma:index="11" nillable="true" ma:taxonomy="true" ma:internalName="TaxKeywordTaxHTField" ma:taxonomyFieldName="TaxKeyword" ma:displayName="Enterprise Keywords" ma:fieldId="{23f27201-bee3-471e-b2e7-b64fd8b7ca38}" ma:taxonomyMulti="true" ma:sspId="1f131a42-a101-40b7-aecc-f7ea1becb290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  <xsd:element name="TaxCatchAll" ma:index="12" nillable="true" ma:displayName="Taxonomy Catch All Column" ma:hidden="true" ma:list="{e4773684-3804-47dc-bc9e-0ebedeee6c79}" ma:internalName="TaxCatchAll" ma:showField="CatchAllData" ma:web="059fc547-a1e4-4b8d-82b9-78eec4423d8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62b03c-6c27-4192-848d-cb0b6cbee78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2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7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Finished xmlns="059fc547-a1e4-4b8d-82b9-78eec4423d84">false</Finished>
    <_Status xmlns="http://schemas.microsoft.com/sharepoint/v3/fields">Not Started</_Status>
    <TaxCatchAll xmlns="059fc547-a1e4-4b8d-82b9-78eec4423d84"/>
    <TaxKeywordTaxHTField xmlns="059fc547-a1e4-4b8d-82b9-78eec4423d84">
      <Terms xmlns="http://schemas.microsoft.com/office/infopath/2007/PartnerControls"/>
    </TaxKeywordTaxHTField>
  </documentManagement>
</p:properties>
</file>

<file path=customXml/itemProps1.xml><?xml version="1.0" encoding="utf-8"?>
<ds:datastoreItem xmlns:ds="http://schemas.openxmlformats.org/officeDocument/2006/customXml" ds:itemID="{6597DAB8-A4AA-4633-813A-43E785487C7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D153AF9-DC2B-4AB1-BA79-128308CA3A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059fc547-a1e4-4b8d-82b9-78eec4423d84"/>
    <ds:schemaRef ds:uri="4762b03c-6c27-4192-848d-cb0b6cbee78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652EEDE-A021-4E16-9A64-315DC918B140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4762b03c-6c27-4192-848d-cb0b6cbee78a"/>
    <ds:schemaRef ds:uri="http://purl.org/dc/elements/1.1/"/>
    <ds:schemaRef ds:uri="http://schemas.microsoft.com/office/2006/metadata/properties"/>
    <ds:schemaRef ds:uri="059fc547-a1e4-4b8d-82b9-78eec4423d84"/>
    <ds:schemaRef ds:uri="http://schemas.microsoft.com/sharepoint/v3/field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6</Words>
  <Application>Microsoft Office PowerPoint</Application>
  <PresentationFormat>Custom</PresentationFormat>
  <Paragraphs>1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er, Dr. Kathrin</dc:creator>
  <cp:keywords/>
  <cp:lastModifiedBy>Hemmer, Dr. Kathrin</cp:lastModifiedBy>
  <cp:revision>13</cp:revision>
  <dcterms:created xsi:type="dcterms:W3CDTF">2020-06-25T13:29:52Z</dcterms:created>
  <dcterms:modified xsi:type="dcterms:W3CDTF">2021-03-30T07:54:10Z</dcterms:modified>
  <cp:contentStatus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D96A27105234489861BEF6E86B06D4</vt:lpwstr>
  </property>
  <property fmtid="{D5CDD505-2E9C-101B-9397-08002B2CF9AE}" pid="3" name="TaxKeyword">
    <vt:lpwstr/>
  </property>
</Properties>
</file>